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  <p:sldId id="258" r:id="rId5"/>
    <p:sldId id="260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4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8435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7875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7504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566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8828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6540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3090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2477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6607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6335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1797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18C39-BFA7-4648-BA19-B996314C1236}" type="datetimeFigureOut">
              <a:rPr lang="es-ES" smtClean="0"/>
              <a:t>25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92FC7-88B1-4A76-AC58-44DCCF2CC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414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6EFAC522-2722-0F9E-5EE6-67819858A481}"/>
              </a:ext>
            </a:extLst>
          </p:cNvPr>
          <p:cNvSpPr/>
          <p:nvPr/>
        </p:nvSpPr>
        <p:spPr>
          <a:xfrm>
            <a:off x="0" y="6241053"/>
            <a:ext cx="9803423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analyzer analysis of RNA samples using the Agilent RNA 6000 Pico assay. (A, B) Representative electrophoresis images and profiles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. (C, D) Representative electrophoresis images and profiles of EV-derived RNA samples. Internal standard control size is 25 base pairs (bp). Abbreviations,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ll free RNA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igital PCR; EV-RNA, extracellular vesicle RNA</a:t>
            </a: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CF6D0513-88DB-4F04-EED9-82DA05D66709}"/>
              </a:ext>
            </a:extLst>
          </p:cNvPr>
          <p:cNvGrpSpPr/>
          <p:nvPr/>
        </p:nvGrpSpPr>
        <p:grpSpPr>
          <a:xfrm>
            <a:off x="883136" y="3806943"/>
            <a:ext cx="2173246" cy="2301478"/>
            <a:chOff x="-464268" y="1331395"/>
            <a:chExt cx="3440055" cy="3643036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11D563A8-E0DC-F1F0-E35E-FECCBE8AA8B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32899" y="1698431"/>
              <a:ext cx="2442888" cy="3276000"/>
              <a:chOff x="404970" y="1469975"/>
              <a:chExt cx="3402624" cy="4563030"/>
            </a:xfrm>
          </p:grpSpPr>
          <p:pic>
            <p:nvPicPr>
              <p:cNvPr id="29" name="Imagen 28">
                <a:extLst>
                  <a:ext uri="{FF2B5EF4-FFF2-40B4-BE49-F238E27FC236}">
                    <a16:creationId xmlns:a16="http://schemas.microsoft.com/office/drawing/2014/main" id="{DB5DC41C-DE3C-A841-E149-BBE08D27BC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61876" t="31971" r="16962" b="12929"/>
              <a:stretch/>
            </p:blipFill>
            <p:spPr>
              <a:xfrm>
                <a:off x="1767774" y="1469975"/>
                <a:ext cx="2039820" cy="4563030"/>
              </a:xfrm>
              <a:prstGeom prst="rect">
                <a:avLst/>
              </a:prstGeom>
            </p:spPr>
          </p:pic>
          <p:pic>
            <p:nvPicPr>
              <p:cNvPr id="30" name="Imagen 29">
                <a:extLst>
                  <a:ext uri="{FF2B5EF4-FFF2-40B4-BE49-F238E27FC236}">
                    <a16:creationId xmlns:a16="http://schemas.microsoft.com/office/drawing/2014/main" id="{63724E83-21A1-9F45-49A4-E139166CCA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2855" t="31975" r="72551" b="13029"/>
              <a:stretch/>
            </p:blipFill>
            <p:spPr>
              <a:xfrm>
                <a:off x="404970" y="1470319"/>
                <a:ext cx="1406772" cy="4554412"/>
              </a:xfrm>
              <a:prstGeom prst="rect">
                <a:avLst/>
              </a:prstGeom>
            </p:spPr>
          </p:pic>
        </p:grp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363B2F4E-AB7F-5102-8D79-95CFF66F2E3E}"/>
                </a:ext>
              </a:extLst>
            </p:cNvPr>
            <p:cNvSpPr txBox="1"/>
            <p:nvPr/>
          </p:nvSpPr>
          <p:spPr>
            <a:xfrm>
              <a:off x="-464268" y="2220589"/>
              <a:ext cx="1033234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4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3608181C-4E66-33B1-E983-96C505071E5A}"/>
                </a:ext>
              </a:extLst>
            </p:cNvPr>
            <p:cNvSpPr txBox="1"/>
            <p:nvPr/>
          </p:nvSpPr>
          <p:spPr>
            <a:xfrm>
              <a:off x="-464268" y="2857424"/>
              <a:ext cx="1033234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2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B1749F66-53BC-85FF-2954-1B7BC97328B3}"/>
                </a:ext>
              </a:extLst>
            </p:cNvPr>
            <p:cNvSpPr txBox="1"/>
            <p:nvPr/>
          </p:nvSpPr>
          <p:spPr>
            <a:xfrm>
              <a:off x="-464268" y="3344806"/>
              <a:ext cx="1033234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1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9286F24E-197D-4476-6F1A-12840172DDA7}"/>
                </a:ext>
              </a:extLst>
            </p:cNvPr>
            <p:cNvSpPr txBox="1"/>
            <p:nvPr/>
          </p:nvSpPr>
          <p:spPr>
            <a:xfrm>
              <a:off x="-350085" y="3720774"/>
              <a:ext cx="919051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5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74A2F2AE-38C1-1D23-3CAB-0F2575172CFD}"/>
                </a:ext>
              </a:extLst>
            </p:cNvPr>
            <p:cNvSpPr txBox="1"/>
            <p:nvPr/>
          </p:nvSpPr>
          <p:spPr>
            <a:xfrm>
              <a:off x="-350085" y="4059326"/>
              <a:ext cx="919051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2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F3A97E3D-7DEF-DDA7-1462-A8000C4380C9}"/>
                </a:ext>
              </a:extLst>
            </p:cNvPr>
            <p:cNvSpPr txBox="1"/>
            <p:nvPr/>
          </p:nvSpPr>
          <p:spPr>
            <a:xfrm>
              <a:off x="-235901" y="4461927"/>
              <a:ext cx="804867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25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7769A7DC-E64B-20CA-090D-C181696AFA34}"/>
                </a:ext>
              </a:extLst>
            </p:cNvPr>
            <p:cNvSpPr txBox="1"/>
            <p:nvPr/>
          </p:nvSpPr>
          <p:spPr>
            <a:xfrm>
              <a:off x="213193" y="1408324"/>
              <a:ext cx="916513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err="1">
                  <a:cs typeface="Arial" panose="020B0604020202020204" pitchFamily="34" charset="0"/>
                </a:rPr>
                <a:t>Ladder</a:t>
              </a:r>
              <a:endParaRPr lang="es-ES" sz="1100" dirty="0">
                <a:cs typeface="Arial" panose="020B0604020202020204" pitchFamily="34" charset="0"/>
              </a:endParaRP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00207249-4D93-0311-CDBF-E4B2B67B9D57}"/>
                </a:ext>
              </a:extLst>
            </p:cNvPr>
            <p:cNvSpPr txBox="1"/>
            <p:nvPr/>
          </p:nvSpPr>
          <p:spPr>
            <a:xfrm>
              <a:off x="1154023" y="1331395"/>
              <a:ext cx="403956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91A379A5-8567-9448-B97B-3866A1B5E0CD}"/>
                </a:ext>
              </a:extLst>
            </p:cNvPr>
            <p:cNvSpPr txBox="1"/>
            <p:nvPr/>
          </p:nvSpPr>
          <p:spPr>
            <a:xfrm>
              <a:off x="1623858" y="1331395"/>
              <a:ext cx="403956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0D7FAFFE-AE1F-1E0C-3274-2BC968EBE0D0}"/>
                </a:ext>
              </a:extLst>
            </p:cNvPr>
            <p:cNvSpPr txBox="1"/>
            <p:nvPr/>
          </p:nvSpPr>
          <p:spPr>
            <a:xfrm>
              <a:off x="2093692" y="1331395"/>
              <a:ext cx="403956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9EE3F396-4EF0-4124-1284-E9D6F878C401}"/>
                </a:ext>
              </a:extLst>
            </p:cNvPr>
            <p:cNvSpPr txBox="1"/>
            <p:nvPr/>
          </p:nvSpPr>
          <p:spPr>
            <a:xfrm>
              <a:off x="2563530" y="1331395"/>
              <a:ext cx="403956" cy="414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cs typeface="Times New Roman" panose="02020603050405020304" pitchFamily="18" charset="0"/>
                </a:rPr>
                <a:t>4</a:t>
              </a:r>
            </a:p>
          </p:txBody>
        </p:sp>
      </p:grpSp>
      <p:pic>
        <p:nvPicPr>
          <p:cNvPr id="13" name="Imagen 12">
            <a:extLst>
              <a:ext uri="{FF2B5EF4-FFF2-40B4-BE49-F238E27FC236}">
                <a16:creationId xmlns:a16="http://schemas.microsoft.com/office/drawing/2014/main" id="{121D6C83-485E-A948-63C0-E7FDED7B01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1341" y="4019086"/>
            <a:ext cx="2440160" cy="997330"/>
          </a:xfrm>
          <a:prstGeom prst="rect">
            <a:avLst/>
          </a:prstGeom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09B0F15B-42A5-82C9-A669-7FB1EB9665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11341" y="5106918"/>
            <a:ext cx="2440160" cy="997328"/>
          </a:xfrm>
          <a:prstGeom prst="rect">
            <a:avLst/>
          </a:prstGeom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303532DE-F48E-8392-B2EA-C8CA3F9D16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2597" y="4019086"/>
            <a:ext cx="2440160" cy="997330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577504A1-7D19-A179-D554-5C47FCB0D7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82597" y="5106918"/>
            <a:ext cx="2440160" cy="997328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A10CAA6B-C426-D396-8B5E-2F45C9C5B513}"/>
              </a:ext>
            </a:extLst>
          </p:cNvPr>
          <p:cNvSpPr txBox="1"/>
          <p:nvPr/>
        </p:nvSpPr>
        <p:spPr>
          <a:xfrm>
            <a:off x="4896002" y="3849034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1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3537A40-A0C0-7AED-3478-B0CBC0BB239F}"/>
              </a:ext>
            </a:extLst>
          </p:cNvPr>
          <p:cNvSpPr txBox="1"/>
          <p:nvPr/>
        </p:nvSpPr>
        <p:spPr>
          <a:xfrm>
            <a:off x="4896002" y="5016055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2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8BA4E8AC-65DF-8092-C0F1-FBD3F1250EE0}"/>
              </a:ext>
            </a:extLst>
          </p:cNvPr>
          <p:cNvSpPr txBox="1"/>
          <p:nvPr/>
        </p:nvSpPr>
        <p:spPr>
          <a:xfrm>
            <a:off x="7622769" y="3863211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3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D5CF0E4B-6190-5617-62B6-AF358D91A071}"/>
              </a:ext>
            </a:extLst>
          </p:cNvPr>
          <p:cNvSpPr txBox="1"/>
          <p:nvPr/>
        </p:nvSpPr>
        <p:spPr>
          <a:xfrm>
            <a:off x="7622769" y="5030232"/>
            <a:ext cx="7120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4</a:t>
            </a:r>
            <a:endParaRPr lang="es-ES" sz="1400" dirty="0">
              <a:cs typeface="Times New Roman" panose="02020603050405020304" pitchFamily="18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C0E60271-8C54-53ED-AD5C-BB12840E80B2}"/>
              </a:ext>
            </a:extLst>
          </p:cNvPr>
          <p:cNvSpPr txBox="1"/>
          <p:nvPr/>
        </p:nvSpPr>
        <p:spPr>
          <a:xfrm>
            <a:off x="333817" y="352604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8ED7B47-801A-8472-6518-067EEA0CA28F}"/>
              </a:ext>
            </a:extLst>
          </p:cNvPr>
          <p:cNvSpPr txBox="1"/>
          <p:nvPr/>
        </p:nvSpPr>
        <p:spPr>
          <a:xfrm>
            <a:off x="3882384" y="352604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1" name="Grupo 30">
            <a:extLst>
              <a:ext uri="{FF2B5EF4-FFF2-40B4-BE49-F238E27FC236}">
                <a16:creationId xmlns:a16="http://schemas.microsoft.com/office/drawing/2014/main" id="{4AE6DC76-AB4E-30B2-218E-C874A84E36DC}"/>
              </a:ext>
            </a:extLst>
          </p:cNvPr>
          <p:cNvGrpSpPr/>
          <p:nvPr/>
        </p:nvGrpSpPr>
        <p:grpSpPr>
          <a:xfrm>
            <a:off x="888119" y="799948"/>
            <a:ext cx="2098170" cy="2589077"/>
            <a:chOff x="2135706" y="1658881"/>
            <a:chExt cx="2180536" cy="3222611"/>
          </a:xfrm>
        </p:grpSpPr>
        <p:sp>
          <p:nvSpPr>
            <p:cNvPr id="32" name="CuadroTexto 7">
              <a:extLst>
                <a:ext uri="{FF2B5EF4-FFF2-40B4-BE49-F238E27FC236}">
                  <a16:creationId xmlns:a16="http://schemas.microsoft.com/office/drawing/2014/main" id="{6CA25487-1293-6B73-9CE8-753C16E9E6EA}"/>
                </a:ext>
              </a:extLst>
            </p:cNvPr>
            <p:cNvSpPr txBox="1"/>
            <p:nvPr/>
          </p:nvSpPr>
          <p:spPr>
            <a:xfrm>
              <a:off x="2135706" y="2744153"/>
              <a:ext cx="678367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4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33" name="CuadroTexto 7">
              <a:extLst>
                <a:ext uri="{FF2B5EF4-FFF2-40B4-BE49-F238E27FC236}">
                  <a16:creationId xmlns:a16="http://schemas.microsoft.com/office/drawing/2014/main" id="{EC60E7CB-918F-B216-D09F-3A9E78CFFD66}"/>
                </a:ext>
              </a:extLst>
            </p:cNvPr>
            <p:cNvSpPr txBox="1"/>
            <p:nvPr/>
          </p:nvSpPr>
          <p:spPr>
            <a:xfrm>
              <a:off x="2135706" y="3286977"/>
              <a:ext cx="678367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2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34" name="CuadroTexto 7">
              <a:extLst>
                <a:ext uri="{FF2B5EF4-FFF2-40B4-BE49-F238E27FC236}">
                  <a16:creationId xmlns:a16="http://schemas.microsoft.com/office/drawing/2014/main" id="{DE1CDCDD-FBA0-E8F9-4E33-8E8FCC139A6C}"/>
                </a:ext>
              </a:extLst>
            </p:cNvPr>
            <p:cNvSpPr txBox="1"/>
            <p:nvPr/>
          </p:nvSpPr>
          <p:spPr>
            <a:xfrm>
              <a:off x="2135706" y="3662405"/>
              <a:ext cx="678367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10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A0D03021-BA27-CFA6-05F5-85F77CAC153B}"/>
                </a:ext>
              </a:extLst>
            </p:cNvPr>
            <p:cNvSpPr txBox="1"/>
            <p:nvPr/>
          </p:nvSpPr>
          <p:spPr>
            <a:xfrm>
              <a:off x="2210674" y="3981819"/>
              <a:ext cx="603400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5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36" name="CuadroTexto 7">
              <a:extLst>
                <a:ext uri="{FF2B5EF4-FFF2-40B4-BE49-F238E27FC236}">
                  <a16:creationId xmlns:a16="http://schemas.microsoft.com/office/drawing/2014/main" id="{3A006AFA-B29B-14AA-16BE-B5CFF4D8F61C}"/>
                </a:ext>
              </a:extLst>
            </p:cNvPr>
            <p:cNvSpPr txBox="1"/>
            <p:nvPr/>
          </p:nvSpPr>
          <p:spPr>
            <a:xfrm>
              <a:off x="2210674" y="4226441"/>
              <a:ext cx="603400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200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sp>
          <p:nvSpPr>
            <p:cNvPr id="37" name="CuadroTexto 7">
              <a:extLst>
                <a:ext uri="{FF2B5EF4-FFF2-40B4-BE49-F238E27FC236}">
                  <a16:creationId xmlns:a16="http://schemas.microsoft.com/office/drawing/2014/main" id="{0BD2A7A9-8E96-73F0-FA5B-22ED04027929}"/>
                </a:ext>
              </a:extLst>
            </p:cNvPr>
            <p:cNvSpPr txBox="1"/>
            <p:nvPr/>
          </p:nvSpPr>
          <p:spPr>
            <a:xfrm>
              <a:off x="2285641" y="4503863"/>
              <a:ext cx="528434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1100" dirty="0">
                  <a:cs typeface="Times New Roman" panose="02020603050405020304" pitchFamily="18" charset="0"/>
                </a:rPr>
                <a:t>25 </a:t>
              </a:r>
              <a:r>
                <a:rPr lang="es-ES" sz="1100" dirty="0" err="1">
                  <a:cs typeface="Times New Roman" panose="02020603050405020304" pitchFamily="18" charset="0"/>
                </a:rPr>
                <a:t>bp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0BB5250E-D581-2C46-31FB-78E08A4C76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" t="12221" r="11487" b="13906"/>
            <a:stretch/>
          </p:blipFill>
          <p:spPr>
            <a:xfrm>
              <a:off x="3074318" y="1836843"/>
              <a:ext cx="341754" cy="3044649"/>
            </a:xfrm>
            <a:prstGeom prst="rect">
              <a:avLst/>
            </a:prstGeom>
          </p:spPr>
        </p:pic>
        <p:pic>
          <p:nvPicPr>
            <p:cNvPr id="39" name="Imagen 38">
              <a:extLst>
                <a:ext uri="{FF2B5EF4-FFF2-40B4-BE49-F238E27FC236}">
                  <a16:creationId xmlns:a16="http://schemas.microsoft.com/office/drawing/2014/main" id="{615B7697-DD7F-A2F4-7CBE-86DD0C6261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22362" r="15907" b="14771"/>
            <a:stretch/>
          </p:blipFill>
          <p:spPr>
            <a:xfrm>
              <a:off x="2766550" y="1954635"/>
              <a:ext cx="341754" cy="2887632"/>
            </a:xfrm>
            <a:prstGeom prst="rect">
              <a:avLst/>
            </a:prstGeom>
          </p:spPr>
        </p:pic>
        <p:pic>
          <p:nvPicPr>
            <p:cNvPr id="40" name="Imagen 39">
              <a:extLst>
                <a:ext uri="{FF2B5EF4-FFF2-40B4-BE49-F238E27FC236}">
                  <a16:creationId xmlns:a16="http://schemas.microsoft.com/office/drawing/2014/main" id="{926DC8CC-CA27-4452-E8D3-12C14FAA3C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9610" t="17721" r="29260" b="15608"/>
            <a:stretch/>
          </p:blipFill>
          <p:spPr>
            <a:xfrm>
              <a:off x="3421527" y="1950012"/>
              <a:ext cx="256477" cy="2892254"/>
            </a:xfrm>
            <a:prstGeom prst="rect">
              <a:avLst/>
            </a:prstGeom>
          </p:spPr>
        </p:pic>
        <p:pic>
          <p:nvPicPr>
            <p:cNvPr id="41" name="Imagen 40">
              <a:extLst>
                <a:ext uri="{FF2B5EF4-FFF2-40B4-BE49-F238E27FC236}">
                  <a16:creationId xmlns:a16="http://schemas.microsoft.com/office/drawing/2014/main" id="{194786DC-1A7B-8F25-CCFE-479431BFD3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4387" t="17721" r="11367" b="17652"/>
            <a:stretch/>
          </p:blipFill>
          <p:spPr>
            <a:xfrm>
              <a:off x="3705421" y="1994323"/>
              <a:ext cx="301738" cy="2760100"/>
            </a:xfrm>
            <a:prstGeom prst="rect">
              <a:avLst/>
            </a:prstGeom>
          </p:spPr>
        </p:pic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6291AE48-438F-8727-ED24-3CD3A0AD34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4386" t="19496" r="11368" b="17301"/>
            <a:stretch/>
          </p:blipFill>
          <p:spPr>
            <a:xfrm>
              <a:off x="4014504" y="2006651"/>
              <a:ext cx="301738" cy="2758821"/>
            </a:xfrm>
            <a:prstGeom prst="rect">
              <a:avLst/>
            </a:prstGeom>
          </p:spPr>
        </p:pic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183F2828-F0F0-FF65-A583-B0E68672EA23}"/>
                </a:ext>
              </a:extLst>
            </p:cNvPr>
            <p:cNvSpPr txBox="1"/>
            <p:nvPr/>
          </p:nvSpPr>
          <p:spPr>
            <a:xfrm>
              <a:off x="2422175" y="1658881"/>
              <a:ext cx="601735" cy="325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err="1">
                  <a:cs typeface="Times New Roman" panose="02020603050405020304" pitchFamily="18" charset="0"/>
                </a:rPr>
                <a:t>Ladder</a:t>
              </a:r>
              <a:endParaRPr lang="es-ES" sz="1100" dirty="0">
                <a:cs typeface="Times New Roman" panose="02020603050405020304" pitchFamily="18" charset="0"/>
              </a:endParaRPr>
            </a:p>
          </p:txBody>
        </p:sp>
      </p:grpSp>
      <p:sp>
        <p:nvSpPr>
          <p:cNvPr id="48" name="CuadroTexto 47">
            <a:extLst>
              <a:ext uri="{FF2B5EF4-FFF2-40B4-BE49-F238E27FC236}">
                <a16:creationId xmlns:a16="http://schemas.microsoft.com/office/drawing/2014/main" id="{A8F00030-5D62-8881-73F6-8309E9AD1072}"/>
              </a:ext>
            </a:extLst>
          </p:cNvPr>
          <p:cNvSpPr txBox="1"/>
          <p:nvPr/>
        </p:nvSpPr>
        <p:spPr>
          <a:xfrm>
            <a:off x="400599" y="3570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0" name="Imagen 49">
            <a:extLst>
              <a:ext uri="{FF2B5EF4-FFF2-40B4-BE49-F238E27FC236}">
                <a16:creationId xmlns:a16="http://schemas.microsoft.com/office/drawing/2014/main" id="{549E94EF-B0A7-1CFB-FAEE-8ED33126A8D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11342" y="2123293"/>
            <a:ext cx="2440159" cy="1124805"/>
          </a:xfrm>
          <a:prstGeom prst="rect">
            <a:avLst/>
          </a:prstGeom>
        </p:spPr>
      </p:pic>
      <p:sp>
        <p:nvSpPr>
          <p:cNvPr id="51" name="CuadroTexto 50">
            <a:extLst>
              <a:ext uri="{FF2B5EF4-FFF2-40B4-BE49-F238E27FC236}">
                <a16:creationId xmlns:a16="http://schemas.microsoft.com/office/drawing/2014/main" id="{DBE02181-3C69-B95A-A780-89368C41CA8D}"/>
              </a:ext>
            </a:extLst>
          </p:cNvPr>
          <p:cNvSpPr txBox="1"/>
          <p:nvPr/>
        </p:nvSpPr>
        <p:spPr>
          <a:xfrm>
            <a:off x="4861538" y="2065635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11</a:t>
            </a:r>
          </a:p>
        </p:txBody>
      </p:sp>
      <p:pic>
        <p:nvPicPr>
          <p:cNvPr id="53" name="Imagen 52">
            <a:extLst>
              <a:ext uri="{FF2B5EF4-FFF2-40B4-BE49-F238E27FC236}">
                <a16:creationId xmlns:a16="http://schemas.microsoft.com/office/drawing/2014/main" id="{92EA16F5-530F-57E1-164D-E379313C246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582597" y="2097225"/>
            <a:ext cx="2440160" cy="1149617"/>
          </a:xfrm>
          <a:prstGeom prst="rect">
            <a:avLst/>
          </a:prstGeom>
        </p:spPr>
      </p:pic>
      <p:sp>
        <p:nvSpPr>
          <p:cNvPr id="54" name="CuadroTexto 53">
            <a:extLst>
              <a:ext uri="{FF2B5EF4-FFF2-40B4-BE49-F238E27FC236}">
                <a16:creationId xmlns:a16="http://schemas.microsoft.com/office/drawing/2014/main" id="{97A60015-E33D-E32C-53F9-6490CEFB1B7E}"/>
              </a:ext>
            </a:extLst>
          </p:cNvPr>
          <p:cNvSpPr txBox="1"/>
          <p:nvPr/>
        </p:nvSpPr>
        <p:spPr>
          <a:xfrm>
            <a:off x="7588305" y="2059504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27</a:t>
            </a:r>
          </a:p>
        </p:txBody>
      </p:sp>
      <p:pic>
        <p:nvPicPr>
          <p:cNvPr id="56" name="Imagen 55">
            <a:extLst>
              <a:ext uri="{FF2B5EF4-FFF2-40B4-BE49-F238E27FC236}">
                <a16:creationId xmlns:a16="http://schemas.microsoft.com/office/drawing/2014/main" id="{425AF5B9-47DF-34FC-C97A-2ACB6306B4F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11341" y="981590"/>
            <a:ext cx="2440160" cy="1124806"/>
          </a:xfrm>
          <a:prstGeom prst="rect">
            <a:avLst/>
          </a:prstGeom>
        </p:spPr>
      </p:pic>
      <p:sp>
        <p:nvSpPr>
          <p:cNvPr id="57" name="CuadroTexto 56">
            <a:extLst>
              <a:ext uri="{FF2B5EF4-FFF2-40B4-BE49-F238E27FC236}">
                <a16:creationId xmlns:a16="http://schemas.microsoft.com/office/drawing/2014/main" id="{B752F4BB-1F98-2792-8179-6926419DC8CC}"/>
              </a:ext>
            </a:extLst>
          </p:cNvPr>
          <p:cNvSpPr txBox="1"/>
          <p:nvPr/>
        </p:nvSpPr>
        <p:spPr>
          <a:xfrm>
            <a:off x="4897605" y="927913"/>
            <a:ext cx="7088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1</a:t>
            </a:r>
          </a:p>
        </p:txBody>
      </p:sp>
      <p:pic>
        <p:nvPicPr>
          <p:cNvPr id="59" name="Imagen 58">
            <a:extLst>
              <a:ext uri="{FF2B5EF4-FFF2-40B4-BE49-F238E27FC236}">
                <a16:creationId xmlns:a16="http://schemas.microsoft.com/office/drawing/2014/main" id="{DCED7607-CA1E-BC49-E46D-57F99E88F73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537312" y="956739"/>
            <a:ext cx="2530731" cy="1166554"/>
          </a:xfrm>
          <a:prstGeom prst="rect">
            <a:avLst/>
          </a:prstGeom>
        </p:spPr>
      </p:pic>
      <p:sp>
        <p:nvSpPr>
          <p:cNvPr id="60" name="CuadroTexto 59">
            <a:extLst>
              <a:ext uri="{FF2B5EF4-FFF2-40B4-BE49-F238E27FC236}">
                <a16:creationId xmlns:a16="http://schemas.microsoft.com/office/drawing/2014/main" id="{87EBE0B2-6133-3248-A2F4-5A9E082D2A37}"/>
              </a:ext>
            </a:extLst>
          </p:cNvPr>
          <p:cNvSpPr txBox="1"/>
          <p:nvPr/>
        </p:nvSpPr>
        <p:spPr>
          <a:xfrm>
            <a:off x="7624372" y="889880"/>
            <a:ext cx="7088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cs typeface="Times New Roman" panose="02020603050405020304" pitchFamily="18" charset="0"/>
              </a:rPr>
              <a:t>Sample</a:t>
            </a:r>
            <a:r>
              <a:rPr lang="es-ES" sz="1100" dirty="0">
                <a:cs typeface="Times New Roman" panose="02020603050405020304" pitchFamily="18" charset="0"/>
              </a:rPr>
              <a:t> 4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5C84BEF3-58CB-2725-42D1-6C57FA19A4BB}"/>
              </a:ext>
            </a:extLst>
          </p:cNvPr>
          <p:cNvSpPr txBox="1"/>
          <p:nvPr/>
        </p:nvSpPr>
        <p:spPr>
          <a:xfrm>
            <a:off x="3944833" y="35701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0" name="CuadroTexto 89">
            <a:extLst>
              <a:ext uri="{FF2B5EF4-FFF2-40B4-BE49-F238E27FC236}">
                <a16:creationId xmlns:a16="http://schemas.microsoft.com/office/drawing/2014/main" id="{D6CB13A2-DA7B-215B-D969-B230AFD0D390}"/>
              </a:ext>
            </a:extLst>
          </p:cNvPr>
          <p:cNvSpPr txBox="1"/>
          <p:nvPr/>
        </p:nvSpPr>
        <p:spPr>
          <a:xfrm>
            <a:off x="1844543" y="766077"/>
            <a:ext cx="1194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/>
              <a:t>1      4      11      27</a:t>
            </a:r>
          </a:p>
        </p:txBody>
      </p:sp>
    </p:spTree>
    <p:extLst>
      <p:ext uri="{BB962C8B-B14F-4D97-AF65-F5344CB8AC3E}">
        <p14:creationId xmlns:p14="http://schemas.microsoft.com/office/powerpoint/2010/main" val="645759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uadroTexto 31">
            <a:extLst>
              <a:ext uri="{FF2B5EF4-FFF2-40B4-BE49-F238E27FC236}">
                <a16:creationId xmlns:a16="http://schemas.microsoft.com/office/drawing/2014/main" id="{8DDDC392-30D1-2C10-76DA-D34D7F40FBFD}"/>
              </a:ext>
            </a:extLst>
          </p:cNvPr>
          <p:cNvSpPr txBox="1"/>
          <p:nvPr/>
        </p:nvSpPr>
        <p:spPr>
          <a:xfrm>
            <a:off x="926170" y="8117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D4BB5E91-0C2F-1821-E3CA-12DC2AAD0B67}"/>
              </a:ext>
            </a:extLst>
          </p:cNvPr>
          <p:cNvSpPr txBox="1"/>
          <p:nvPr/>
        </p:nvSpPr>
        <p:spPr>
          <a:xfrm>
            <a:off x="4871119" y="81173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D3A3CEB1-BA19-4580-1FC4-9893C7892C76}"/>
              </a:ext>
            </a:extLst>
          </p:cNvPr>
          <p:cNvSpPr txBox="1"/>
          <p:nvPr/>
        </p:nvSpPr>
        <p:spPr>
          <a:xfrm>
            <a:off x="0" y="6020104"/>
            <a:ext cx="924736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chnical variation of nCounter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, B) Levey-Jennings charts showing the geomean of housekeeping counts and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C6-RE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sion counts in six repeated nCounter runs of th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a RET positive patient. (C) Levey-Jennings charts showing the allelic fraction of ten repeate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uns of a control sample (H2228 cell line) for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L4-ALK v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D) Representative image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control samples. Abbreviations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ll free RNA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igital PCR; EV-RNA, extracellular vesicle RNA; HK, housekeeping; MAF, variant allelic frequency</a:t>
            </a:r>
            <a:endParaRPr lang="es-E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5" name="Objeto 34">
            <a:extLst>
              <a:ext uri="{FF2B5EF4-FFF2-40B4-BE49-F238E27FC236}">
                <a16:creationId xmlns:a16="http://schemas.microsoft.com/office/drawing/2014/main" id="{7EB8A5F6-47AC-B1A2-1E3E-C08B339484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822822"/>
              </p:ext>
            </p:extLst>
          </p:nvPr>
        </p:nvGraphicFramePr>
        <p:xfrm>
          <a:off x="816993" y="3839288"/>
          <a:ext cx="3452506" cy="18477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982847" imgH="2666596" progId="Prism8.Document">
                  <p:embed/>
                </p:oleObj>
              </mc:Choice>
              <mc:Fallback>
                <p:oleObj name="Prism 8" r:id="rId2" imgW="4982847" imgH="2666596" progId="Prism8.Document">
                  <p:embed/>
                  <p:pic>
                    <p:nvPicPr>
                      <p:cNvPr id="12" name="Objeto 11">
                        <a:extLst>
                          <a:ext uri="{FF2B5EF4-FFF2-40B4-BE49-F238E27FC236}">
                            <a16:creationId xmlns:a16="http://schemas.microsoft.com/office/drawing/2014/main" id="{2533101A-BE7F-7B34-D589-C3106874DF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16993" y="3839288"/>
                        <a:ext cx="3452506" cy="18477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6" name="Imagen 35">
            <a:extLst>
              <a:ext uri="{FF2B5EF4-FFF2-40B4-BE49-F238E27FC236}">
                <a16:creationId xmlns:a16="http://schemas.microsoft.com/office/drawing/2014/main" id="{4A442FB1-FAE4-8182-9024-F6C96FACA6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53000" y="1099527"/>
            <a:ext cx="4048237" cy="2333591"/>
          </a:xfrm>
          <a:prstGeom prst="rect">
            <a:avLst/>
          </a:prstGeom>
        </p:spPr>
      </p:pic>
      <p:pic>
        <p:nvPicPr>
          <p:cNvPr id="37" name="Imagen 36">
            <a:extLst>
              <a:ext uri="{FF2B5EF4-FFF2-40B4-BE49-F238E27FC236}">
                <a16:creationId xmlns:a16="http://schemas.microsoft.com/office/drawing/2014/main" id="{D89FFB8D-DD88-8BD5-E48F-526BC1FFC6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9227" y="1162993"/>
            <a:ext cx="3828039" cy="2206659"/>
          </a:xfrm>
          <a:prstGeom prst="rect">
            <a:avLst/>
          </a:prstGeom>
        </p:spPr>
      </p:pic>
      <p:sp>
        <p:nvSpPr>
          <p:cNvPr id="38" name="CuadroTexto 37">
            <a:extLst>
              <a:ext uri="{FF2B5EF4-FFF2-40B4-BE49-F238E27FC236}">
                <a16:creationId xmlns:a16="http://schemas.microsoft.com/office/drawing/2014/main" id="{32D7213A-A9D9-DF0E-650D-37F73A080226}"/>
              </a:ext>
            </a:extLst>
          </p:cNvPr>
          <p:cNvSpPr txBox="1"/>
          <p:nvPr/>
        </p:nvSpPr>
        <p:spPr>
          <a:xfrm>
            <a:off x="930979" y="334698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74570BDB-2B8D-E069-134F-EAE0B0C80320}"/>
              </a:ext>
            </a:extLst>
          </p:cNvPr>
          <p:cNvSpPr txBox="1"/>
          <p:nvPr/>
        </p:nvSpPr>
        <p:spPr>
          <a:xfrm>
            <a:off x="4864995" y="334698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87025F9E-9928-6D0D-416F-FDB7E067F65C}"/>
              </a:ext>
            </a:extLst>
          </p:cNvPr>
          <p:cNvGrpSpPr/>
          <p:nvPr/>
        </p:nvGrpSpPr>
        <p:grpSpPr>
          <a:xfrm>
            <a:off x="5365300" y="3734748"/>
            <a:ext cx="3710328" cy="1894641"/>
            <a:chOff x="6069781" y="1741066"/>
            <a:chExt cx="4163319" cy="2719206"/>
          </a:xfrm>
        </p:grpSpPr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id="{FC196BA6-8C5D-2D81-DAC8-D59F5F7596A9}"/>
                </a:ext>
              </a:extLst>
            </p:cNvPr>
            <p:cNvGrpSpPr/>
            <p:nvPr/>
          </p:nvGrpSpPr>
          <p:grpSpPr>
            <a:xfrm>
              <a:off x="6069781" y="1741066"/>
              <a:ext cx="4163319" cy="2719206"/>
              <a:chOff x="3534399" y="1907320"/>
              <a:chExt cx="4163319" cy="2719206"/>
            </a:xfrm>
          </p:grpSpPr>
          <p:pic>
            <p:nvPicPr>
              <p:cNvPr id="5" name="Marcador de contenido 3">
                <a:extLst>
                  <a:ext uri="{FF2B5EF4-FFF2-40B4-BE49-F238E27FC236}">
                    <a16:creationId xmlns:a16="http://schemas.microsoft.com/office/drawing/2014/main" id="{58743404-7361-FEDA-A607-5DB573215E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421" t="5899" r="1680" b="5374"/>
              <a:stretch/>
            </p:blipFill>
            <p:spPr>
              <a:xfrm>
                <a:off x="3841404" y="2210320"/>
                <a:ext cx="3698239" cy="2137385"/>
              </a:xfrm>
              <a:prstGeom prst="rect">
                <a:avLst/>
              </a:prstGeom>
            </p:spPr>
          </p:pic>
          <p:sp>
            <p:nvSpPr>
              <p:cNvPr id="6" name="CuadroTexto 5">
                <a:extLst>
                  <a:ext uri="{FF2B5EF4-FFF2-40B4-BE49-F238E27FC236}">
                    <a16:creationId xmlns:a16="http://schemas.microsoft.com/office/drawing/2014/main" id="{6A226B99-6865-EE9F-2A56-E63D20AC0FD4}"/>
                  </a:ext>
                </a:extLst>
              </p:cNvPr>
              <p:cNvSpPr txBox="1"/>
              <p:nvPr/>
            </p:nvSpPr>
            <p:spPr>
              <a:xfrm>
                <a:off x="3534399" y="1907320"/>
                <a:ext cx="416331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i="1" dirty="0">
                    <a:solidFill>
                      <a:srgbClr val="296CD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AM: 432  </a:t>
                </a:r>
                <a:r>
                  <a:rPr lang="es-ES" sz="800" b="1" i="1" dirty="0">
                    <a:solidFill>
                      <a:srgbClr val="E94E4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IC:7375</a:t>
                </a:r>
                <a:r>
                  <a:rPr lang="es-E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s-ES" sz="800" b="1" i="1" dirty="0">
                    <a:solidFill>
                      <a:srgbClr val="69AE2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AM+VIC:390 </a:t>
                </a:r>
                <a:r>
                  <a:rPr lang="es-E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="1" i="1" dirty="0">
                    <a:solidFill>
                      <a:srgbClr val="4D4D4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NDETERMINED:2</a:t>
                </a:r>
                <a:r>
                  <a:rPr lang="es-ES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s-ES" sz="800" b="1" i="1" dirty="0">
                    <a:solidFill>
                      <a:srgbClr val="FFCC1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 AMPLIFICATION: 7823</a:t>
                </a:r>
              </a:p>
            </p:txBody>
          </p:sp>
          <p:sp>
            <p:nvSpPr>
              <p:cNvPr id="7" name="Rectángulo 6">
                <a:extLst>
                  <a:ext uri="{FF2B5EF4-FFF2-40B4-BE49-F238E27FC236}">
                    <a16:creationId xmlns:a16="http://schemas.microsoft.com/office/drawing/2014/main" id="{93C19F67-E76E-4F97-9CEF-A4A49AD307DD}"/>
                  </a:ext>
                </a:extLst>
              </p:cNvPr>
              <p:cNvSpPr/>
              <p:nvPr/>
            </p:nvSpPr>
            <p:spPr>
              <a:xfrm rot="16200000">
                <a:off x="3423792" y="3022940"/>
                <a:ext cx="48282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M</a:t>
                </a:r>
                <a:endParaRPr lang="es-ES" sz="1100" i="1" dirty="0"/>
              </a:p>
            </p:txBody>
          </p:sp>
          <p:sp>
            <p:nvSpPr>
              <p:cNvPr id="8" name="Rectángulo 7">
                <a:extLst>
                  <a:ext uri="{FF2B5EF4-FFF2-40B4-BE49-F238E27FC236}">
                    <a16:creationId xmlns:a16="http://schemas.microsoft.com/office/drawing/2014/main" id="{CDC25987-9D86-B99C-02CD-A40DC9E33C6D}"/>
                  </a:ext>
                </a:extLst>
              </p:cNvPr>
              <p:cNvSpPr/>
              <p:nvPr/>
            </p:nvSpPr>
            <p:spPr>
              <a:xfrm>
                <a:off x="5757895" y="4364916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IC</a:t>
                </a:r>
                <a:endParaRPr lang="es-ES" sz="1100" i="1" dirty="0"/>
              </a:p>
            </p:txBody>
          </p:sp>
        </p:grp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8C9607EF-4B87-B223-C56D-3085F896544A}"/>
                </a:ext>
              </a:extLst>
            </p:cNvPr>
            <p:cNvSpPr txBox="1"/>
            <p:nvPr/>
          </p:nvSpPr>
          <p:spPr>
            <a:xfrm>
              <a:off x="8950047" y="3733169"/>
              <a:ext cx="1283053" cy="360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AF = 7,33 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57629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C3250CDF-98BD-B13E-E58F-135E9895ABDF}"/>
              </a:ext>
            </a:extLst>
          </p:cNvPr>
          <p:cNvSpPr txBox="1"/>
          <p:nvPr/>
        </p:nvSpPr>
        <p:spPr>
          <a:xfrm>
            <a:off x="5024841" y="987447"/>
            <a:ext cx="3970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7059908C-62B1-180B-8F54-B6FDCB5D049D}"/>
              </a:ext>
            </a:extLst>
          </p:cNvPr>
          <p:cNvSpPr txBox="1"/>
          <p:nvPr/>
        </p:nvSpPr>
        <p:spPr>
          <a:xfrm>
            <a:off x="125080" y="6024429"/>
            <a:ext cx="9276382" cy="6235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nCounter counts. (A) Plot of the geomean of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usekeeping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counts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NA quantification by Qubit in t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tracts. Each point represents a sample. The best lineal regression is plotted, together with the R2 value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Comparison of the total number of counts in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ve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sma samples vs other fluids. 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= not significant (a two-tailed Mann-Whitney U test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ll free RNA; HK, housekeeping.</a:t>
            </a:r>
            <a:endParaRPr lang="es-E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7ABBA5C-0FDD-8407-DE8D-CE31845CA7E1}"/>
              </a:ext>
            </a:extLst>
          </p:cNvPr>
          <p:cNvSpPr txBox="1"/>
          <p:nvPr/>
        </p:nvSpPr>
        <p:spPr>
          <a:xfrm>
            <a:off x="1206367" y="987447"/>
            <a:ext cx="406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5EA893AC-502E-B36F-F016-AFDE5C2B11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6367" y="1729936"/>
            <a:ext cx="3527837" cy="3207757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D9EB7EF9-A8FF-B693-A314-5EEB188C6D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0997" y="787069"/>
            <a:ext cx="2966304" cy="4365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85708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02AB553-24FF-3790-E518-3BE859393D35}"/>
              </a:ext>
            </a:extLst>
          </p:cNvPr>
          <p:cNvSpPr txBox="1"/>
          <p:nvPr/>
        </p:nvSpPr>
        <p:spPr>
          <a:xfrm>
            <a:off x="59966" y="6204975"/>
            <a:ext cx="977579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mparison of the total mRNA counts corresponding to th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sekeeping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s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fusion-positive and negative samples by nCounter. ns= 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t significant (in a two-tailed Mann-Whitney U test). </a:t>
            </a:r>
            <a:endParaRPr kumimoji="0" lang="es-E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8AD1FBA4-FA37-F0EC-B6EE-5243827AD6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9479" y="479150"/>
            <a:ext cx="3074587" cy="52819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27955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DD5E3415-C6CB-5A41-A85C-166BF942336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95275" y="142039"/>
            <a:ext cx="9610725" cy="1495425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E59ED8C3-AF3D-0AA9-76D2-A969ED4328E0}"/>
              </a:ext>
            </a:extLst>
          </p:cNvPr>
          <p:cNvSpPr txBox="1"/>
          <p:nvPr/>
        </p:nvSpPr>
        <p:spPr>
          <a:xfrm>
            <a:off x="159379" y="3126799"/>
            <a:ext cx="271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s-ES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BA50495-1D8C-65B9-DC6D-C5D1A43C05FD}"/>
              </a:ext>
            </a:extLst>
          </p:cNvPr>
          <p:cNvSpPr txBox="1"/>
          <p:nvPr/>
        </p:nvSpPr>
        <p:spPr>
          <a:xfrm>
            <a:off x="124656" y="325488"/>
            <a:ext cx="2989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42558312-572F-B9EB-AC03-950561873626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8922" y="3113903"/>
            <a:ext cx="3050421" cy="3744097"/>
          </a:xfrm>
          <a:prstGeom prst="rect">
            <a:avLst/>
          </a:prstGeom>
        </p:spPr>
      </p:pic>
      <p:sp>
        <p:nvSpPr>
          <p:cNvPr id="6" name="CuadroTexto 3">
            <a:extLst>
              <a:ext uri="{FF2B5EF4-FFF2-40B4-BE49-F238E27FC236}">
                <a16:creationId xmlns:a16="http://schemas.microsoft.com/office/drawing/2014/main" id="{B9FE8DA6-859D-8814-6136-9315944ED1EF}"/>
              </a:ext>
            </a:extLst>
          </p:cNvPr>
          <p:cNvSpPr txBox="1"/>
          <p:nvPr/>
        </p:nvSpPr>
        <p:spPr>
          <a:xfrm>
            <a:off x="3779343" y="4443208"/>
            <a:ext cx="5903374" cy="17488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257175">
              <a:lnSpc>
                <a:spcPct val="107000"/>
              </a:lnSpc>
              <a:spcAft>
                <a:spcPts val="253"/>
              </a:spcAft>
            </a:pP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V-RNA analysis (A) Heatmap of the EV-RNA samples (n=28) included in the study. All samples were analyzed by nCounter and </a:t>
            </a:r>
            <a:r>
              <a:rPr lang="en-US" sz="11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Green, concordant samples detected by nCounter and </a:t>
            </a:r>
            <a:r>
              <a:rPr lang="en-US" sz="11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White, discordant samples detected only by nCounter or </a:t>
            </a:r>
            <a:r>
              <a:rPr lang="en-US" sz="11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Grey, samples not evaluable. Orange, 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K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sitive sampl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pink,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ex14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icing positive samples; yellow, 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T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itive samples;  blue, negative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.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the geometric means of the HK gene counts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positive, negative and not evaluable samples by </a:t>
            </a:r>
            <a:r>
              <a:rPr lang="en-US" sz="11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Counter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**p &lt;0.01; ***p&lt;0.001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a two-tailed Mann-Whitney U test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bbreviations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C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igital PCR; EV-RNA, extracellular vesicle RNA; NE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, negative</a:t>
            </a:r>
            <a:endParaRPr kumimoji="0" lang="es-E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7D3A4469-04D9-E58D-BB10-8C3C9D465E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3441" y="1628839"/>
            <a:ext cx="7315200" cy="1343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26428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9</TotalTime>
  <Words>534</Words>
  <Application>Microsoft Office PowerPoint</Application>
  <PresentationFormat>A4 (210 x 297 mm)</PresentationFormat>
  <Paragraphs>48</Paragraphs>
  <Slides>5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Prism 8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Angel Molina</dc:creator>
  <cp:lastModifiedBy>Miguel Angel Molina</cp:lastModifiedBy>
  <cp:revision>13</cp:revision>
  <dcterms:created xsi:type="dcterms:W3CDTF">2023-04-26T08:35:19Z</dcterms:created>
  <dcterms:modified xsi:type="dcterms:W3CDTF">2023-05-25T08:52:04Z</dcterms:modified>
</cp:coreProperties>
</file>